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C980D-B83F-4A25-A725-C351DE03F5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02329A-74CB-4300-A947-BAEE1AF5F9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456F18-686B-42BA-A5C2-D4EE72364F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C5ABB-055F-4CAD-B524-338315379A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B8651-B671-43E2-9EF5-06DD9F3355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9B0F2F-DC00-47AB-A624-21201E7F90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6272BD-D4F1-4B91-9A80-134A0652B4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909C3B-919B-4D72-9352-DB965DCE71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E40E7A-86C5-40E7-B1BD-FF993FBC07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B8A22-5CA0-4A23-A9F6-A261A87E0F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F2E1B-8CCA-40BB-A211-F20047A59C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82783-AD42-4F00-929F-93BD8F862D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1800"/>
            <a:ext cx="1600200" cy="52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1800"/>
            <a:ext cx="2171520" cy="52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1800"/>
            <a:ext cx="1600200" cy="52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8DBC6E-7193-442D-85A0-A772A36C7E3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747720" y="2021040"/>
            <a:ext cx="5729400" cy="4023000"/>
          </a:xfrm>
          <a:prstGeom prst="rect">
            <a:avLst/>
          </a:prstGeom>
          <a:solidFill>
            <a:srgbClr val="f2f2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tage I (screening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ndom split sample set: stage I 25 / stage II 35/5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reening set with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 RNA  samples taken before irradiation (unexposed) representing H0 HA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2x5 RNA samples from days1&amp;2 after irradiation, representing  HARS without pancytopeni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2x5 RNA samples from days1&amp;2 after irradiation, representing HARS with pancytopeni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RNA transcriptome (whole genome microarray, 19,596 gene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ARS with and without pancytopenia relative to unexposed sampl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~ 2,000-3,000  up- and down-regulated genes for both HARS groups and both 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~ 2-3 times more up- than down-regulated genes overlapping at both days and detected in both HARS group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gene enrichment analysis (PANTHER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→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51 mRNA for stage II</a:t>
            </a:r>
            <a:r>
              <a:rPr b="1" lang="de-DE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AutoNum type="arabicPeriod" startAt="4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ost-transcriptome (low density array, LDA, 667 miRNA specie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685800" indent="-228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→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23 miRNA for stage II</a:t>
            </a:r>
            <a:r>
              <a:rPr b="1" lang="de-DE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6"/>
          <p:cNvSpPr/>
          <p:nvPr/>
        </p:nvSpPr>
        <p:spPr>
          <a:xfrm>
            <a:off x="747720" y="6095880"/>
            <a:ext cx="5729400" cy="118980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tage II (validat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alidation set with 35/50 samples, respectively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descriptive statistic of candidate genes (t-test, Kruskal-Wallis, where appropriate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logistic regression analysis to examine  gene expression association among the unexposed group and HARS groups with or without pancytopenia, when appropri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→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validated genes: 11 mRNAs + 9 miRNA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10"/>
          <p:cNvSpPr/>
          <p:nvPr/>
        </p:nvSpPr>
        <p:spPr>
          <a:xfrm>
            <a:off x="685800" y="1258920"/>
            <a:ext cx="5791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Online resource 1: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low diagram of included samples, split study design, gene expression measurements and bioinformatic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0T18:16:56Z</dcterms:created>
  <dc:creator>temp</dc:creator>
  <dc:description/>
  <dc:language>en-US</dc:language>
  <cp:lastModifiedBy>Matthaeus Majewski</cp:lastModifiedBy>
  <cp:lastPrinted>2016-10-11T14:36:31Z</cp:lastPrinted>
  <dcterms:modified xsi:type="dcterms:W3CDTF">2017-02-07T12:36:54Z</dcterms:modified>
  <cp:revision>111</cp:revision>
  <dc:subject/>
  <dc:title>Slide 1</dc:title>
</cp:coreProperties>
</file>